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34" r:id="rId2"/>
    <p:sldId id="335" r:id="rId3"/>
    <p:sldId id="336" r:id="rId4"/>
    <p:sldId id="337" r:id="rId5"/>
    <p:sldId id="342" r:id="rId6"/>
    <p:sldId id="33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ngala Rao" initials="MR" lastIdx="2" clrIdx="0">
    <p:extLst>
      <p:ext uri="{19B8F6BF-5375-455C-9EA6-DF929625EA0E}">
        <p15:presenceInfo xmlns:p15="http://schemas.microsoft.com/office/powerpoint/2012/main" userId="S::mrao@ad.hjf.org::5e38edf3-0252-4fbe-8283-088c8556f8a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54"/>
    <p:restoredTop sz="94694"/>
  </p:normalViewPr>
  <p:slideViewPr>
    <p:cSldViewPr snapToGrid="0" snapToObjects="1">
      <p:cViewPr varScale="1">
        <p:scale>
          <a:sx n="101" d="100"/>
          <a:sy n="101" d="100"/>
        </p:scale>
        <p:origin x="200" y="7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0F2460-1C38-884A-8607-517DBF53E5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F34709-F641-004D-BC29-1E6CC218BF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E2E263-2F57-3546-918E-2C1EF2EE5C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4A02D4-8251-944F-A239-707C6622A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781C9E-1FF9-7546-97E6-6ACEB8461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671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6684C-3CDF-E244-902F-61C7EF3E7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B8368C-8A38-0146-A327-1FF60E4AC3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7E96BC-9612-764E-B9C0-403975F9A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6FDF82-D5FE-4448-B213-9A832F0A7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7AB9EB-0EB4-F341-A73B-990BE1207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11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32C20A-6276-614F-BC6C-2A0AC003B7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BC3ED0-C4B0-BF40-AD2B-32E796DE1D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F1D5F9-FCB2-E343-9581-43B902254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F69276-8BE7-2243-BFED-3EDE4556A5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77339D-B0EA-C340-A5CB-C7F5A4FFD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089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12919F-4106-7F4E-AD92-2FE7CD6A88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DBF284-B8E6-0942-9403-5D0321AFE4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180DB9-A524-9045-B47C-BEB52AB15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60C384-8A70-3542-96B3-D93ED6F5C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AD0026-35F4-3945-AE9B-BFFFD3E39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665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A75D7D-077D-1844-9269-28E642667E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6F7F19-697C-384A-A6A4-23F0A6C85A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1BEF41-070D-6C4D-9FF6-AD59F96C4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0157E7-38F4-AC43-A8E9-D89F5D603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D43693-0C02-B44D-A3D2-9F2101D4F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210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66F0AC-4290-0F4E-AFE0-4F0D3D3B0C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1C16F5-DABB-2149-8A14-6F4E4B68EE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D446B8-4A47-4B4F-A126-77C10F9184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34992A-2EEE-0344-BA85-FABA92D31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975761-B871-6F44-BE3E-71D9DB7B1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0C7C3A-6A3F-CA4A-8077-ADEA86280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326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88727E-34CC-FA43-A19A-CEAF6FECDF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5B33A8-B7A1-CE42-B53A-56DCCDCB17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91827E-AF64-814E-A22C-D558B9573A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3F8C3D-5DBC-FE49-A1B2-98A5BF24BE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BA1A9DB-3236-114D-80D7-573B1596C7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AA4868-7F12-6948-A752-A00B72DAF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18BB45B-4A52-E64A-96BA-07F7FAD292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12E7DCB-0FD8-7644-982E-41C54540F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9888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B9CB8C-3ED6-B74C-ACED-4389D74DD8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E057464-153D-6245-AA20-F5B104685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A93557A-5368-564E-85E2-B848799FC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5A80C0-1ED3-0D41-AC4B-2D775FCCF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519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19CF616-4D8A-AD45-A980-165A835F9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CC8465-68D0-734A-8BB1-63A2880473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D422390-74D3-0547-A5CB-014638E9A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7468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550F42-D6B0-BB46-BF50-419B23FBD9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56A778-5421-7346-9CB4-A332742A9E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247C0E-67A7-D840-9891-4FDDD7D2F3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63A854-F04F-CC4E-BB0B-E7F67C017F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B11721-A426-0743-939B-93D88ADB3D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D15EDB-A9CB-A84A-8C36-A233B0104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864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3F6C14-E184-2847-BB30-9AB084EB61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9451FD-E2FB-F543-8BA0-C0123B6296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439240-7E0E-1746-AADC-C0EF679E8C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E1DE7D-8D19-A348-8A2C-B64879980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FA6AEF-DF4C-0B4F-932A-D052EC6260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9A96F6-3A6E-9943-939A-7EC8C2BBD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677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5439D5D-26AB-924D-B7C9-1DD7BE03EC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AB074D-2A98-E249-AC6E-0448003CAB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A26F2C-E001-B54E-B4E0-B1F700F798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783D3-2795-F14F-BC31-252653F300E4}" type="datetimeFigureOut">
              <a:rPr lang="en-US" smtClean="0"/>
              <a:t>5/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4A9E85-78A5-E04F-AF70-45A79C1EB3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6AC7EF-7312-7E40-94EC-7E01684808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AFAE0-8473-1E41-9189-6A5D4BD992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518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0A032B7-291A-914D-8420-5F1065D77E6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623" t="4315" r="6516" b="3149"/>
          <a:stretch/>
        </p:blipFill>
        <p:spPr>
          <a:xfrm>
            <a:off x="1040525" y="1839314"/>
            <a:ext cx="3942677" cy="330883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6C13059-12D2-844F-90CD-FE2CFB3A067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992" t="5538" r="3350" b="-1546"/>
          <a:stretch/>
        </p:blipFill>
        <p:spPr>
          <a:xfrm>
            <a:off x="5980388" y="1839312"/>
            <a:ext cx="4403835" cy="33088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EBD5721B-335A-BD44-B41D-9FD17A7DCBE4}"/>
              </a:ext>
            </a:extLst>
          </p:cNvPr>
          <p:cNvSpPr txBox="1"/>
          <p:nvPr/>
        </p:nvSpPr>
        <p:spPr>
          <a:xfrm>
            <a:off x="624420" y="5689378"/>
            <a:ext cx="10122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1. Western blots for SAMHD1 shown in Fig. 9A without cropping for (A) Donors 118 and 170, (B) Donors 205 and 008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FCE6EA7-8D64-6F4A-BF01-B5350BD98073}"/>
              </a:ext>
            </a:extLst>
          </p:cNvPr>
          <p:cNvSpPr txBox="1"/>
          <p:nvPr/>
        </p:nvSpPr>
        <p:spPr>
          <a:xfrm>
            <a:off x="791863" y="1304548"/>
            <a:ext cx="3819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B6511E5-9706-B246-9AD7-AE71F12D47E6}"/>
              </a:ext>
            </a:extLst>
          </p:cNvPr>
          <p:cNvSpPr txBox="1"/>
          <p:nvPr/>
        </p:nvSpPr>
        <p:spPr>
          <a:xfrm>
            <a:off x="5722777" y="1304548"/>
            <a:ext cx="3819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BA27E19-019E-E444-8886-5B61D6847438}"/>
              </a:ext>
            </a:extLst>
          </p:cNvPr>
          <p:cNvSpPr txBox="1"/>
          <p:nvPr/>
        </p:nvSpPr>
        <p:spPr>
          <a:xfrm>
            <a:off x="2419256" y="770986"/>
            <a:ext cx="932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onor 118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80B57A2-349E-AE4F-A5BC-1834E698359F}"/>
              </a:ext>
            </a:extLst>
          </p:cNvPr>
          <p:cNvSpPr txBox="1"/>
          <p:nvPr/>
        </p:nvSpPr>
        <p:spPr>
          <a:xfrm>
            <a:off x="3270215" y="770986"/>
            <a:ext cx="932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onor 17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D00D923-7875-6F4B-A281-6C3C67CFE7E9}"/>
              </a:ext>
            </a:extLst>
          </p:cNvPr>
          <p:cNvSpPr txBox="1"/>
          <p:nvPr/>
        </p:nvSpPr>
        <p:spPr>
          <a:xfrm rot="16200000">
            <a:off x="2107698" y="1249247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58A410A-845D-494B-9438-2958E1DD1726}"/>
              </a:ext>
            </a:extLst>
          </p:cNvPr>
          <p:cNvSpPr txBox="1"/>
          <p:nvPr/>
        </p:nvSpPr>
        <p:spPr>
          <a:xfrm rot="16200000">
            <a:off x="2579409" y="1471466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C20EA80-A088-7949-B974-3069B7F5503B}"/>
              </a:ext>
            </a:extLst>
          </p:cNvPr>
          <p:cNvSpPr txBox="1"/>
          <p:nvPr/>
        </p:nvSpPr>
        <p:spPr>
          <a:xfrm rot="16200000">
            <a:off x="2800013" y="1476232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243D835-AF0C-4141-924F-C316168B71F9}"/>
              </a:ext>
            </a:extLst>
          </p:cNvPr>
          <p:cNvSpPr txBox="1"/>
          <p:nvPr/>
        </p:nvSpPr>
        <p:spPr>
          <a:xfrm rot="16200000">
            <a:off x="2854520" y="1249247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5EB4E30-A933-574F-B12E-820D3472E753}"/>
              </a:ext>
            </a:extLst>
          </p:cNvPr>
          <p:cNvSpPr txBox="1"/>
          <p:nvPr/>
        </p:nvSpPr>
        <p:spPr>
          <a:xfrm rot="16200000">
            <a:off x="3326231" y="1471466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981A80F-8026-B24E-A0AA-80B36C041355}"/>
              </a:ext>
            </a:extLst>
          </p:cNvPr>
          <p:cNvSpPr txBox="1"/>
          <p:nvPr/>
        </p:nvSpPr>
        <p:spPr>
          <a:xfrm rot="16200000">
            <a:off x="3546835" y="1476232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8B89C00-FBC9-5544-BE33-A8D004E5EC43}"/>
              </a:ext>
            </a:extLst>
          </p:cNvPr>
          <p:cNvSpPr txBox="1"/>
          <p:nvPr/>
        </p:nvSpPr>
        <p:spPr>
          <a:xfrm rot="16200000">
            <a:off x="1194522" y="4516034"/>
            <a:ext cx="1119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BMC lysat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A2D2C685-650D-0C46-BF0E-939600C4506D}"/>
              </a:ext>
            </a:extLst>
          </p:cNvPr>
          <p:cNvCxnSpPr>
            <a:cxnSpLocks/>
          </p:cNvCxnSpPr>
          <p:nvPr/>
        </p:nvCxnSpPr>
        <p:spPr>
          <a:xfrm flipH="1">
            <a:off x="4125790" y="3158598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C939B5E4-7A57-2B46-BC5F-1AF01336E94F}"/>
              </a:ext>
            </a:extLst>
          </p:cNvPr>
          <p:cNvSpPr txBox="1"/>
          <p:nvPr/>
        </p:nvSpPr>
        <p:spPr>
          <a:xfrm>
            <a:off x="4305101" y="3040560"/>
            <a:ext cx="9321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AMHD1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462E1F4-64A9-B340-9436-BF3BE0E0D5D7}"/>
              </a:ext>
            </a:extLst>
          </p:cNvPr>
          <p:cNvCxnSpPr>
            <a:cxnSpLocks/>
          </p:cNvCxnSpPr>
          <p:nvPr/>
        </p:nvCxnSpPr>
        <p:spPr>
          <a:xfrm>
            <a:off x="3365540" y="996747"/>
            <a:ext cx="7497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429D43C4-4E12-0E47-82D2-00B66396EEE9}"/>
              </a:ext>
            </a:extLst>
          </p:cNvPr>
          <p:cNvCxnSpPr>
            <a:cxnSpLocks/>
          </p:cNvCxnSpPr>
          <p:nvPr/>
        </p:nvCxnSpPr>
        <p:spPr>
          <a:xfrm>
            <a:off x="2510442" y="996747"/>
            <a:ext cx="7497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0819340D-2472-CA4D-8D95-94A3067D3415}"/>
              </a:ext>
            </a:extLst>
          </p:cNvPr>
          <p:cNvSpPr txBox="1"/>
          <p:nvPr/>
        </p:nvSpPr>
        <p:spPr>
          <a:xfrm>
            <a:off x="7383996" y="752228"/>
            <a:ext cx="932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onor 20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2B6C1AA-05B7-BA40-9B97-DF8009FB7677}"/>
              </a:ext>
            </a:extLst>
          </p:cNvPr>
          <p:cNvSpPr txBox="1"/>
          <p:nvPr/>
        </p:nvSpPr>
        <p:spPr>
          <a:xfrm>
            <a:off x="8234955" y="752228"/>
            <a:ext cx="932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onor 008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8836601-0D95-394A-AA0F-730751269C5E}"/>
              </a:ext>
            </a:extLst>
          </p:cNvPr>
          <p:cNvSpPr txBox="1"/>
          <p:nvPr/>
        </p:nvSpPr>
        <p:spPr>
          <a:xfrm rot="16200000">
            <a:off x="6883258" y="1230489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955DC8C-D47C-A941-8992-68CED58601E2}"/>
              </a:ext>
            </a:extLst>
          </p:cNvPr>
          <p:cNvSpPr txBox="1"/>
          <p:nvPr/>
        </p:nvSpPr>
        <p:spPr>
          <a:xfrm rot="16200000">
            <a:off x="7375989" y="1452708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3E7D275-7E59-6948-AA62-F891F322E623}"/>
              </a:ext>
            </a:extLst>
          </p:cNvPr>
          <p:cNvSpPr txBox="1"/>
          <p:nvPr/>
        </p:nvSpPr>
        <p:spPr>
          <a:xfrm rot="16200000">
            <a:off x="7670163" y="1457474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8EDF4F4-0801-B841-BB96-090C4CCB1019}"/>
              </a:ext>
            </a:extLst>
          </p:cNvPr>
          <p:cNvSpPr txBox="1"/>
          <p:nvPr/>
        </p:nvSpPr>
        <p:spPr>
          <a:xfrm rot="16200000">
            <a:off x="7777220" y="1230489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94153BD-10D0-7B41-8ACB-63FF776186D5}"/>
              </a:ext>
            </a:extLst>
          </p:cNvPr>
          <p:cNvSpPr txBox="1"/>
          <p:nvPr/>
        </p:nvSpPr>
        <p:spPr>
          <a:xfrm rot="16200000">
            <a:off x="8311991" y="1452708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F23E4E7-AD6B-9446-AD36-68F2C15D426F}"/>
              </a:ext>
            </a:extLst>
          </p:cNvPr>
          <p:cNvSpPr txBox="1"/>
          <p:nvPr/>
        </p:nvSpPr>
        <p:spPr>
          <a:xfrm rot="16200000">
            <a:off x="8616675" y="1457474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20A761A3-74A6-8547-8EB2-4DCD2742A094}"/>
              </a:ext>
            </a:extLst>
          </p:cNvPr>
          <p:cNvCxnSpPr>
            <a:cxnSpLocks/>
          </p:cNvCxnSpPr>
          <p:nvPr/>
        </p:nvCxnSpPr>
        <p:spPr>
          <a:xfrm flipH="1">
            <a:off x="9521459" y="3109017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2FD38F3B-97B6-FE4A-B9B0-93CA7AEBD08B}"/>
              </a:ext>
            </a:extLst>
          </p:cNvPr>
          <p:cNvSpPr txBox="1"/>
          <p:nvPr/>
        </p:nvSpPr>
        <p:spPr>
          <a:xfrm>
            <a:off x="9700770" y="2990979"/>
            <a:ext cx="9321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AMHD1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C90C5908-FDA8-3B40-A07D-BF059447C970}"/>
              </a:ext>
            </a:extLst>
          </p:cNvPr>
          <p:cNvCxnSpPr>
            <a:cxnSpLocks/>
          </p:cNvCxnSpPr>
          <p:nvPr/>
        </p:nvCxnSpPr>
        <p:spPr>
          <a:xfrm>
            <a:off x="8330280" y="977989"/>
            <a:ext cx="7497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3D8CEFA8-B9C4-A642-8B04-DEBCE3478940}"/>
              </a:ext>
            </a:extLst>
          </p:cNvPr>
          <p:cNvCxnSpPr>
            <a:cxnSpLocks/>
          </p:cNvCxnSpPr>
          <p:nvPr/>
        </p:nvCxnSpPr>
        <p:spPr>
          <a:xfrm>
            <a:off x="7475182" y="977989"/>
            <a:ext cx="7497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90EB43CD-8449-524F-A1ED-7F99088C5390}"/>
              </a:ext>
            </a:extLst>
          </p:cNvPr>
          <p:cNvSpPr txBox="1"/>
          <p:nvPr/>
        </p:nvSpPr>
        <p:spPr>
          <a:xfrm rot="16200000">
            <a:off x="6070499" y="4414915"/>
            <a:ext cx="13678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onocyte lysate</a:t>
            </a:r>
          </a:p>
        </p:txBody>
      </p:sp>
    </p:spTree>
    <p:extLst>
      <p:ext uri="{BB962C8B-B14F-4D97-AF65-F5344CB8AC3E}">
        <p14:creationId xmlns:p14="http://schemas.microsoft.com/office/powerpoint/2010/main" val="6122266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65E1AAB-DBB5-5948-9CC6-18B1F0FDED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035" t="8698" r="13793" b="8158"/>
          <a:stretch/>
        </p:blipFill>
        <p:spPr>
          <a:xfrm>
            <a:off x="6096000" y="2168261"/>
            <a:ext cx="4099855" cy="323747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8D50F97-2159-AE40-B8F0-B531742D137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757" t="10718" r="35233" b="46388"/>
          <a:stretch/>
        </p:blipFill>
        <p:spPr>
          <a:xfrm>
            <a:off x="902044" y="2168261"/>
            <a:ext cx="4213654" cy="313407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1F2CB90-D2E0-5B41-9DA9-8566520E64F6}"/>
              </a:ext>
            </a:extLst>
          </p:cNvPr>
          <p:cNvSpPr txBox="1"/>
          <p:nvPr/>
        </p:nvSpPr>
        <p:spPr>
          <a:xfrm>
            <a:off x="675548" y="1656366"/>
            <a:ext cx="3819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D635AAC-E3DF-AD4C-AF83-B58B890F9559}"/>
              </a:ext>
            </a:extLst>
          </p:cNvPr>
          <p:cNvSpPr txBox="1"/>
          <p:nvPr/>
        </p:nvSpPr>
        <p:spPr>
          <a:xfrm>
            <a:off x="5858707" y="1656366"/>
            <a:ext cx="3819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5B03839-ACF3-0E4E-953F-A3C074F47370}"/>
              </a:ext>
            </a:extLst>
          </p:cNvPr>
          <p:cNvSpPr txBox="1"/>
          <p:nvPr/>
        </p:nvSpPr>
        <p:spPr>
          <a:xfrm rot="16200000">
            <a:off x="1749353" y="1555044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EA04EC-D577-7C46-BD0E-E5D8337BF99B}"/>
              </a:ext>
            </a:extLst>
          </p:cNvPr>
          <p:cNvSpPr txBox="1"/>
          <p:nvPr/>
        </p:nvSpPr>
        <p:spPr>
          <a:xfrm rot="16200000">
            <a:off x="2221064" y="1777263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B03D1B8-A912-ED4B-8179-157888B9C08C}"/>
              </a:ext>
            </a:extLst>
          </p:cNvPr>
          <p:cNvSpPr txBox="1"/>
          <p:nvPr/>
        </p:nvSpPr>
        <p:spPr>
          <a:xfrm rot="16200000">
            <a:off x="2515810" y="1782029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8F58BB5-2E9E-0543-B565-1E58C9F512F7}"/>
              </a:ext>
            </a:extLst>
          </p:cNvPr>
          <p:cNvSpPr txBox="1"/>
          <p:nvPr/>
        </p:nvSpPr>
        <p:spPr>
          <a:xfrm rot="16200000">
            <a:off x="2595031" y="1555044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E94DE28-8989-A44C-99B6-03E43582B111}"/>
              </a:ext>
            </a:extLst>
          </p:cNvPr>
          <p:cNvSpPr txBox="1"/>
          <p:nvPr/>
        </p:nvSpPr>
        <p:spPr>
          <a:xfrm rot="16200000">
            <a:off x="3091456" y="1777263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B8AF5F2-D0AB-C84F-8641-26A2ABEB66F1}"/>
              </a:ext>
            </a:extLst>
          </p:cNvPr>
          <p:cNvSpPr txBox="1"/>
          <p:nvPr/>
        </p:nvSpPr>
        <p:spPr>
          <a:xfrm rot="16200000">
            <a:off x="3386202" y="1782029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FA6EDE66-FA7E-7446-A7D2-C6D5373CAD0C}"/>
              </a:ext>
            </a:extLst>
          </p:cNvPr>
          <p:cNvCxnSpPr>
            <a:cxnSpLocks/>
          </p:cNvCxnSpPr>
          <p:nvPr/>
        </p:nvCxnSpPr>
        <p:spPr>
          <a:xfrm flipH="1">
            <a:off x="4162865" y="3510416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513DF8B2-BDA2-D540-8096-1D15DFA13E00}"/>
              </a:ext>
            </a:extLst>
          </p:cNvPr>
          <p:cNvSpPr txBox="1"/>
          <p:nvPr/>
        </p:nvSpPr>
        <p:spPr>
          <a:xfrm>
            <a:off x="4342176" y="3392378"/>
            <a:ext cx="9321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SAMHD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   (T592)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07F7F2E7-0D47-B448-BED6-8E4A33858642}"/>
              </a:ext>
            </a:extLst>
          </p:cNvPr>
          <p:cNvGrpSpPr/>
          <p:nvPr/>
        </p:nvGrpSpPr>
        <p:grpSpPr>
          <a:xfrm>
            <a:off x="2060911" y="1045181"/>
            <a:ext cx="1783072" cy="276999"/>
            <a:chOff x="2060911" y="1027355"/>
            <a:chExt cx="1783072" cy="276999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02EAEC9-BC4A-3449-BFF5-A85AEA1DEB97}"/>
                </a:ext>
              </a:extLst>
            </p:cNvPr>
            <p:cNvSpPr txBox="1"/>
            <p:nvPr/>
          </p:nvSpPr>
          <p:spPr>
            <a:xfrm>
              <a:off x="2060911" y="1027355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18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C404A62-4806-1749-819D-9FCCB6EC455B}"/>
                </a:ext>
              </a:extLst>
            </p:cNvPr>
            <p:cNvSpPr txBox="1"/>
            <p:nvPr/>
          </p:nvSpPr>
          <p:spPr>
            <a:xfrm>
              <a:off x="2911870" y="1027355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70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1E80530B-A29D-1442-9001-80717447B3F6}"/>
                </a:ext>
              </a:extLst>
            </p:cNvPr>
            <p:cNvCxnSpPr>
              <a:cxnSpLocks/>
            </p:cNvCxnSpPr>
            <p:nvPr/>
          </p:nvCxnSpPr>
          <p:spPr>
            <a:xfrm>
              <a:off x="3007195" y="1253116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F9DD6ADA-27CF-5D48-8E92-423BB5359E0F}"/>
                </a:ext>
              </a:extLst>
            </p:cNvPr>
            <p:cNvCxnSpPr>
              <a:cxnSpLocks/>
            </p:cNvCxnSpPr>
            <p:nvPr/>
          </p:nvCxnSpPr>
          <p:spPr>
            <a:xfrm>
              <a:off x="2152097" y="1253116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925E3AF8-1F30-9149-B166-DBCEAB6A2D35}"/>
              </a:ext>
            </a:extLst>
          </p:cNvPr>
          <p:cNvSpPr txBox="1"/>
          <p:nvPr/>
        </p:nvSpPr>
        <p:spPr>
          <a:xfrm>
            <a:off x="7230173" y="1045181"/>
            <a:ext cx="932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onor 20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03F8D76-5A37-CE43-B029-3B397ABD784C}"/>
              </a:ext>
            </a:extLst>
          </p:cNvPr>
          <p:cNvSpPr txBox="1"/>
          <p:nvPr/>
        </p:nvSpPr>
        <p:spPr>
          <a:xfrm>
            <a:off x="8143763" y="1045181"/>
            <a:ext cx="9321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onor 00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2D64312-C06C-F24C-9C0C-57F4FA405F80}"/>
              </a:ext>
            </a:extLst>
          </p:cNvPr>
          <p:cNvSpPr txBox="1"/>
          <p:nvPr/>
        </p:nvSpPr>
        <p:spPr>
          <a:xfrm rot="16200000">
            <a:off x="6906258" y="1535294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AC4F01D-0791-9944-9CEB-A98A1DBD45BA}"/>
              </a:ext>
            </a:extLst>
          </p:cNvPr>
          <p:cNvSpPr txBox="1"/>
          <p:nvPr/>
        </p:nvSpPr>
        <p:spPr>
          <a:xfrm rot="16200000">
            <a:off x="7390326" y="1757513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7658E86-D6F5-E446-B6AD-0CB41FF177B2}"/>
              </a:ext>
            </a:extLst>
          </p:cNvPr>
          <p:cNvSpPr txBox="1"/>
          <p:nvPr/>
        </p:nvSpPr>
        <p:spPr>
          <a:xfrm rot="16200000">
            <a:off x="7685072" y="1762279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E9DB27D-3976-3E4A-AEF3-29D590209555}"/>
              </a:ext>
            </a:extLst>
          </p:cNvPr>
          <p:cNvSpPr txBox="1"/>
          <p:nvPr/>
        </p:nvSpPr>
        <p:spPr>
          <a:xfrm rot="16200000">
            <a:off x="7764293" y="1535294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3905B01-762B-8B45-AE0A-50E052777E2C}"/>
              </a:ext>
            </a:extLst>
          </p:cNvPr>
          <p:cNvSpPr txBox="1"/>
          <p:nvPr/>
        </p:nvSpPr>
        <p:spPr>
          <a:xfrm rot="16200000">
            <a:off x="8260718" y="1757513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10168B0-F910-E54D-A07A-03D403673DE5}"/>
              </a:ext>
            </a:extLst>
          </p:cNvPr>
          <p:cNvSpPr txBox="1"/>
          <p:nvPr/>
        </p:nvSpPr>
        <p:spPr>
          <a:xfrm rot="16200000">
            <a:off x="8555464" y="1762279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8105B7B6-A7D5-7E41-9C70-B91B222A6153}"/>
              </a:ext>
            </a:extLst>
          </p:cNvPr>
          <p:cNvCxnSpPr>
            <a:cxnSpLocks/>
          </p:cNvCxnSpPr>
          <p:nvPr/>
        </p:nvCxnSpPr>
        <p:spPr>
          <a:xfrm flipH="1">
            <a:off x="9974682" y="3378608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3D3327C6-CCD5-B645-9525-A850D02C16AA}"/>
              </a:ext>
            </a:extLst>
          </p:cNvPr>
          <p:cNvSpPr txBox="1"/>
          <p:nvPr/>
        </p:nvSpPr>
        <p:spPr>
          <a:xfrm>
            <a:off x="10153993" y="3260570"/>
            <a:ext cx="9321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SAMHD1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   (T592)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F796E97C-20C7-D04E-99AF-6CFA37657C0E}"/>
              </a:ext>
            </a:extLst>
          </p:cNvPr>
          <p:cNvCxnSpPr>
            <a:cxnSpLocks/>
          </p:cNvCxnSpPr>
          <p:nvPr/>
        </p:nvCxnSpPr>
        <p:spPr>
          <a:xfrm>
            <a:off x="8239088" y="1270942"/>
            <a:ext cx="7497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027AE7D7-35CF-4E46-BD63-0CBD0AC10E54}"/>
              </a:ext>
            </a:extLst>
          </p:cNvPr>
          <p:cNvCxnSpPr>
            <a:cxnSpLocks/>
          </p:cNvCxnSpPr>
          <p:nvPr/>
        </p:nvCxnSpPr>
        <p:spPr>
          <a:xfrm>
            <a:off x="7358937" y="1270942"/>
            <a:ext cx="7497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80DEBD6A-0D6C-184D-B192-84CB0AB925E1}"/>
              </a:ext>
            </a:extLst>
          </p:cNvPr>
          <p:cNvSpPr txBox="1"/>
          <p:nvPr/>
        </p:nvSpPr>
        <p:spPr>
          <a:xfrm>
            <a:off x="419779" y="5942126"/>
            <a:ext cx="112536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2. Western blots for p-SAMHD1 (T592) shown in Fig. 9A. Blots without cropping for (A) Donors 118 and 170, (B) Donors 205 and 008.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759EE52-43E8-874C-BC67-FD37F6679195}"/>
              </a:ext>
            </a:extLst>
          </p:cNvPr>
          <p:cNvSpPr txBox="1"/>
          <p:nvPr/>
        </p:nvSpPr>
        <p:spPr>
          <a:xfrm rot="16200000">
            <a:off x="1138767" y="4694450"/>
            <a:ext cx="1119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BMC lysate</a:t>
            </a:r>
          </a:p>
        </p:txBody>
      </p:sp>
    </p:spTree>
    <p:extLst>
      <p:ext uri="{BB962C8B-B14F-4D97-AF65-F5344CB8AC3E}">
        <p14:creationId xmlns:p14="http://schemas.microsoft.com/office/powerpoint/2010/main" val="26590834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8EDB472-B620-6346-A435-82C3DF5558B0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21579" t="5523" r="12648" b="17313"/>
          <a:stretch/>
        </p:blipFill>
        <p:spPr>
          <a:xfrm>
            <a:off x="106516" y="2224216"/>
            <a:ext cx="3657600" cy="3657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DEA0322-7DAF-F141-8F20-C4EB5739ECB1}"/>
              </a:ext>
            </a:extLst>
          </p:cNvPr>
          <p:cNvSpPr txBox="1"/>
          <p:nvPr/>
        </p:nvSpPr>
        <p:spPr>
          <a:xfrm rot="16200000">
            <a:off x="1069727" y="1608292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6D07326-05EB-7F41-A100-4582921F5228}"/>
              </a:ext>
            </a:extLst>
          </p:cNvPr>
          <p:cNvSpPr txBox="1"/>
          <p:nvPr/>
        </p:nvSpPr>
        <p:spPr>
          <a:xfrm rot="16200000">
            <a:off x="1541438" y="1830511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303CCA2-26A4-8644-898F-BED8CB0C83CC}"/>
              </a:ext>
            </a:extLst>
          </p:cNvPr>
          <p:cNvSpPr txBox="1"/>
          <p:nvPr/>
        </p:nvSpPr>
        <p:spPr>
          <a:xfrm rot="16200000">
            <a:off x="1749685" y="1835277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C2616333-22FB-FE45-9094-48B94552F56E}"/>
              </a:ext>
            </a:extLst>
          </p:cNvPr>
          <p:cNvCxnSpPr>
            <a:cxnSpLocks/>
          </p:cNvCxnSpPr>
          <p:nvPr/>
        </p:nvCxnSpPr>
        <p:spPr>
          <a:xfrm flipH="1">
            <a:off x="3199566" y="3094789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5DD6E94F-140A-EB41-A1FB-86B8799FF837}"/>
              </a:ext>
            </a:extLst>
          </p:cNvPr>
          <p:cNvSpPr txBox="1"/>
          <p:nvPr/>
        </p:nvSpPr>
        <p:spPr>
          <a:xfrm>
            <a:off x="3378877" y="2976752"/>
            <a:ext cx="5603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FI16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8F9FF2E3-5A47-D34E-9ECF-4626DD7EC372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16454" t="2679" r="11362" b="-2369"/>
          <a:stretch/>
        </p:blipFill>
        <p:spPr>
          <a:xfrm>
            <a:off x="3899986" y="2222985"/>
            <a:ext cx="3657600" cy="3657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BC74F33D-6BEC-AD43-8CE8-6FD8E851213C}"/>
              </a:ext>
            </a:extLst>
          </p:cNvPr>
          <p:cNvSpPr txBox="1"/>
          <p:nvPr/>
        </p:nvSpPr>
        <p:spPr>
          <a:xfrm rot="16200000">
            <a:off x="5722757" y="1608292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CD0BB0-35AC-EF4F-B73F-8C8CCDA1C96B}"/>
              </a:ext>
            </a:extLst>
          </p:cNvPr>
          <p:cNvSpPr txBox="1"/>
          <p:nvPr/>
        </p:nvSpPr>
        <p:spPr>
          <a:xfrm rot="16200000">
            <a:off x="6120329" y="1830511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FDBDBC7-C9D5-5145-AFB7-86B5ECF112A2}"/>
              </a:ext>
            </a:extLst>
          </p:cNvPr>
          <p:cNvSpPr txBox="1"/>
          <p:nvPr/>
        </p:nvSpPr>
        <p:spPr>
          <a:xfrm rot="16200000">
            <a:off x="6340934" y="1852590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8D8DE46-F76C-6042-ADF1-A5740DA0F031}"/>
              </a:ext>
            </a:extLst>
          </p:cNvPr>
          <p:cNvSpPr txBox="1"/>
          <p:nvPr/>
        </p:nvSpPr>
        <p:spPr>
          <a:xfrm>
            <a:off x="1267419" y="5909826"/>
            <a:ext cx="162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ow exposur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300758A-0772-FF41-9DC1-D3DC4FC3C6EE}"/>
              </a:ext>
            </a:extLst>
          </p:cNvPr>
          <p:cNvSpPr txBox="1"/>
          <p:nvPr/>
        </p:nvSpPr>
        <p:spPr>
          <a:xfrm>
            <a:off x="5512142" y="5888146"/>
            <a:ext cx="162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igh exposur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8072731-E046-B544-91A3-9902493686AC}"/>
              </a:ext>
            </a:extLst>
          </p:cNvPr>
          <p:cNvSpPr txBox="1"/>
          <p:nvPr/>
        </p:nvSpPr>
        <p:spPr>
          <a:xfrm rot="16200000">
            <a:off x="497305" y="1602054"/>
            <a:ext cx="1024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ell lysat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975F8FF-CCFC-9549-A04F-0508B23AD87C}"/>
              </a:ext>
            </a:extLst>
          </p:cNvPr>
          <p:cNvSpPr txBox="1"/>
          <p:nvPr/>
        </p:nvSpPr>
        <p:spPr>
          <a:xfrm rot="16200000">
            <a:off x="4227225" y="1602054"/>
            <a:ext cx="1024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ell lysate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C2B71FDA-E0A6-5D42-9E42-CAEE7563DF3B}"/>
              </a:ext>
            </a:extLst>
          </p:cNvPr>
          <p:cNvCxnSpPr>
            <a:cxnSpLocks/>
          </p:cNvCxnSpPr>
          <p:nvPr/>
        </p:nvCxnSpPr>
        <p:spPr>
          <a:xfrm flipH="1">
            <a:off x="6967745" y="3170034"/>
            <a:ext cx="153797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AD8402A0-067D-1749-8C5B-B701A9134C99}"/>
              </a:ext>
            </a:extLst>
          </p:cNvPr>
          <p:cNvSpPr txBox="1"/>
          <p:nvPr/>
        </p:nvSpPr>
        <p:spPr>
          <a:xfrm>
            <a:off x="7086653" y="3051997"/>
            <a:ext cx="5603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I16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08FE35C6-793B-0B45-AE91-17FFF3A2AA2F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l="8790" t="4615" r="-692" b="1796"/>
          <a:stretch/>
        </p:blipFill>
        <p:spPr>
          <a:xfrm>
            <a:off x="7698834" y="2236568"/>
            <a:ext cx="3657600" cy="3657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F40E684A-1A25-7E46-8037-DF9957FBAA0A}"/>
              </a:ext>
            </a:extLst>
          </p:cNvPr>
          <p:cNvSpPr txBox="1"/>
          <p:nvPr/>
        </p:nvSpPr>
        <p:spPr>
          <a:xfrm rot="16200000">
            <a:off x="1864680" y="1608292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9341960-486A-744C-BE39-6B654E42BA22}"/>
              </a:ext>
            </a:extLst>
          </p:cNvPr>
          <p:cNvSpPr txBox="1"/>
          <p:nvPr/>
        </p:nvSpPr>
        <p:spPr>
          <a:xfrm rot="16200000">
            <a:off x="2336391" y="1830511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8F00FCC-B8C4-944F-8FB9-E3282AEF1CD6}"/>
              </a:ext>
            </a:extLst>
          </p:cNvPr>
          <p:cNvSpPr txBox="1"/>
          <p:nvPr/>
        </p:nvSpPr>
        <p:spPr>
          <a:xfrm rot="16200000">
            <a:off x="2544638" y="1835277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E45586CD-430C-0140-9898-43BD716A82BD}"/>
              </a:ext>
            </a:extLst>
          </p:cNvPr>
          <p:cNvGrpSpPr/>
          <p:nvPr/>
        </p:nvGrpSpPr>
        <p:grpSpPr>
          <a:xfrm>
            <a:off x="1467784" y="1097916"/>
            <a:ext cx="1727066" cy="276999"/>
            <a:chOff x="1467784" y="1071327"/>
            <a:chExt cx="1727066" cy="27699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4BC78AD-1B31-2849-8263-315B916B0E50}"/>
                </a:ext>
              </a:extLst>
            </p:cNvPr>
            <p:cNvSpPr txBox="1"/>
            <p:nvPr/>
          </p:nvSpPr>
          <p:spPr>
            <a:xfrm>
              <a:off x="1467784" y="1071327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18</a:t>
              </a: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EA9E002B-79FA-8548-B2C6-2016971F4707}"/>
                </a:ext>
              </a:extLst>
            </p:cNvPr>
            <p:cNvCxnSpPr>
              <a:cxnSpLocks/>
            </p:cNvCxnSpPr>
            <p:nvPr/>
          </p:nvCxnSpPr>
          <p:spPr>
            <a:xfrm>
              <a:off x="1558970" y="1292970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25A5D4B-C323-3544-997C-9CDBA584E4FE}"/>
                </a:ext>
              </a:extLst>
            </p:cNvPr>
            <p:cNvSpPr txBox="1"/>
            <p:nvPr/>
          </p:nvSpPr>
          <p:spPr>
            <a:xfrm>
              <a:off x="2262737" y="1071327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70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1DC9CD56-D394-4243-AC28-CDA42F8FF3D7}"/>
                </a:ext>
              </a:extLst>
            </p:cNvPr>
            <p:cNvCxnSpPr>
              <a:cxnSpLocks/>
            </p:cNvCxnSpPr>
            <p:nvPr/>
          </p:nvCxnSpPr>
          <p:spPr>
            <a:xfrm>
              <a:off x="2353923" y="1297087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C2422315-4C69-DD43-8858-74AE20F3A9BB}"/>
              </a:ext>
            </a:extLst>
          </p:cNvPr>
          <p:cNvSpPr txBox="1"/>
          <p:nvPr/>
        </p:nvSpPr>
        <p:spPr>
          <a:xfrm rot="16200000">
            <a:off x="8242178" y="1625605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7C90731-E6C4-9645-9DBD-5B5F4C7486AA}"/>
              </a:ext>
            </a:extLst>
          </p:cNvPr>
          <p:cNvSpPr txBox="1"/>
          <p:nvPr/>
        </p:nvSpPr>
        <p:spPr>
          <a:xfrm rot="16200000">
            <a:off x="8713889" y="1847824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ED70794-E222-904C-A637-F6FAB8D78BE2}"/>
              </a:ext>
            </a:extLst>
          </p:cNvPr>
          <p:cNvSpPr txBox="1"/>
          <p:nvPr/>
        </p:nvSpPr>
        <p:spPr>
          <a:xfrm rot="16200000">
            <a:off x="8922136" y="1852590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F7B142A9-27C3-CC47-BC92-C75CEA7FB377}"/>
              </a:ext>
            </a:extLst>
          </p:cNvPr>
          <p:cNvCxnSpPr>
            <a:cxnSpLocks/>
          </p:cNvCxnSpPr>
          <p:nvPr/>
        </p:nvCxnSpPr>
        <p:spPr>
          <a:xfrm flipH="1">
            <a:off x="11249352" y="3418906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6450E92F-E818-3940-9F2E-42B399C9AC3E}"/>
              </a:ext>
            </a:extLst>
          </p:cNvPr>
          <p:cNvSpPr txBox="1"/>
          <p:nvPr/>
        </p:nvSpPr>
        <p:spPr>
          <a:xfrm>
            <a:off x="11428663" y="3300869"/>
            <a:ext cx="5603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FI16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105BC46-94EB-0C40-AADC-F48D4870F229}"/>
              </a:ext>
            </a:extLst>
          </p:cNvPr>
          <p:cNvSpPr txBox="1"/>
          <p:nvPr/>
        </p:nvSpPr>
        <p:spPr>
          <a:xfrm rot="16200000">
            <a:off x="9037131" y="1625605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47C24D2-1218-3941-8D06-8B26F62D2A6A}"/>
              </a:ext>
            </a:extLst>
          </p:cNvPr>
          <p:cNvSpPr txBox="1"/>
          <p:nvPr/>
        </p:nvSpPr>
        <p:spPr>
          <a:xfrm rot="16200000">
            <a:off x="9508842" y="1847824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FD7D124-A47F-644E-A5C7-BF2C7BAEF4E6}"/>
              </a:ext>
            </a:extLst>
          </p:cNvPr>
          <p:cNvSpPr txBox="1"/>
          <p:nvPr/>
        </p:nvSpPr>
        <p:spPr>
          <a:xfrm rot="16200000">
            <a:off x="9717089" y="1852590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A4F95254-5137-B448-8F70-136BB72A3597}"/>
              </a:ext>
            </a:extLst>
          </p:cNvPr>
          <p:cNvGrpSpPr/>
          <p:nvPr/>
        </p:nvGrpSpPr>
        <p:grpSpPr>
          <a:xfrm>
            <a:off x="8640235" y="1093799"/>
            <a:ext cx="1727066" cy="281116"/>
            <a:chOff x="8640235" y="1093799"/>
            <a:chExt cx="1727066" cy="281116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E33F9FE-30EB-3349-A05E-7516EFB47027}"/>
                </a:ext>
              </a:extLst>
            </p:cNvPr>
            <p:cNvSpPr txBox="1"/>
            <p:nvPr/>
          </p:nvSpPr>
          <p:spPr>
            <a:xfrm>
              <a:off x="8640235" y="1093799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205</a:t>
              </a:r>
            </a:p>
          </p:txBody>
        </p: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A5A0D05D-3741-B846-8C42-9A91279D83CF}"/>
                </a:ext>
              </a:extLst>
            </p:cNvPr>
            <p:cNvCxnSpPr>
              <a:cxnSpLocks/>
            </p:cNvCxnSpPr>
            <p:nvPr/>
          </p:nvCxnSpPr>
          <p:spPr>
            <a:xfrm>
              <a:off x="8731421" y="1319560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2FDFBED-3972-5C46-B83D-5269820270F0}"/>
                </a:ext>
              </a:extLst>
            </p:cNvPr>
            <p:cNvSpPr txBox="1"/>
            <p:nvPr/>
          </p:nvSpPr>
          <p:spPr>
            <a:xfrm>
              <a:off x="9435188" y="1097916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008</a:t>
              </a:r>
            </a:p>
          </p:txBody>
        </p: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465E1458-35AF-CB4D-8F49-F726740B90E5}"/>
                </a:ext>
              </a:extLst>
            </p:cNvPr>
            <p:cNvCxnSpPr>
              <a:cxnSpLocks/>
            </p:cNvCxnSpPr>
            <p:nvPr/>
          </p:nvCxnSpPr>
          <p:spPr>
            <a:xfrm>
              <a:off x="9526374" y="1323677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EA285444-6AC6-CE45-A8B5-7D7989F8D378}"/>
              </a:ext>
            </a:extLst>
          </p:cNvPr>
          <p:cNvSpPr txBox="1"/>
          <p:nvPr/>
        </p:nvSpPr>
        <p:spPr>
          <a:xfrm>
            <a:off x="0" y="6218072"/>
            <a:ext cx="116738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3. Western blots for IFI16 shown in Fig. 9A without cropping for Donors 118 and 170 at low exposure (A) and high exposure (B), and (C) for Donors 205 and 008.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B123A25-D4D4-3E4C-93BF-00B20C4E737D}"/>
              </a:ext>
            </a:extLst>
          </p:cNvPr>
          <p:cNvSpPr txBox="1"/>
          <p:nvPr/>
        </p:nvSpPr>
        <p:spPr>
          <a:xfrm rot="16200000">
            <a:off x="4849536" y="1608292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8B90AA5-754F-5045-956D-9B9410577192}"/>
              </a:ext>
            </a:extLst>
          </p:cNvPr>
          <p:cNvSpPr txBox="1"/>
          <p:nvPr/>
        </p:nvSpPr>
        <p:spPr>
          <a:xfrm rot="16200000">
            <a:off x="5296536" y="1830511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F0F5B3C-0AAD-E148-BAAA-3F5E0615A40D}"/>
              </a:ext>
            </a:extLst>
          </p:cNvPr>
          <p:cNvSpPr txBox="1"/>
          <p:nvPr/>
        </p:nvSpPr>
        <p:spPr>
          <a:xfrm rot="16200000">
            <a:off x="5566569" y="1835277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63D38B3-FE21-9B4F-9E2D-A0DD1640CF76}"/>
              </a:ext>
            </a:extLst>
          </p:cNvPr>
          <p:cNvGrpSpPr/>
          <p:nvPr/>
        </p:nvGrpSpPr>
        <p:grpSpPr>
          <a:xfrm>
            <a:off x="5194366" y="1097916"/>
            <a:ext cx="1870918" cy="276999"/>
            <a:chOff x="5194366" y="964452"/>
            <a:chExt cx="1870918" cy="276999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8D18800-32AB-FC42-8C1E-FA37C9C041A5}"/>
                </a:ext>
              </a:extLst>
            </p:cNvPr>
            <p:cNvSpPr txBox="1"/>
            <p:nvPr/>
          </p:nvSpPr>
          <p:spPr>
            <a:xfrm>
              <a:off x="6133171" y="964452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70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0668AF52-C712-AB4D-B0B1-5F3655CD6248}"/>
                </a:ext>
              </a:extLst>
            </p:cNvPr>
            <p:cNvCxnSpPr>
              <a:cxnSpLocks/>
            </p:cNvCxnSpPr>
            <p:nvPr/>
          </p:nvCxnSpPr>
          <p:spPr>
            <a:xfrm>
              <a:off x="6224357" y="1205820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ADDD99F-08AD-624D-B458-51565DE6AAAA}"/>
                </a:ext>
              </a:extLst>
            </p:cNvPr>
            <p:cNvSpPr txBox="1"/>
            <p:nvPr/>
          </p:nvSpPr>
          <p:spPr>
            <a:xfrm>
              <a:off x="5194366" y="964452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18</a:t>
              </a: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5DA7E07A-6A84-AF44-8B2C-9DA01D964408}"/>
                </a:ext>
              </a:extLst>
            </p:cNvPr>
            <p:cNvCxnSpPr>
              <a:cxnSpLocks/>
            </p:cNvCxnSpPr>
            <p:nvPr/>
          </p:nvCxnSpPr>
          <p:spPr>
            <a:xfrm>
              <a:off x="5285552" y="1178538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7D937BF7-E8B9-EB48-A5CF-FD9300D780C8}"/>
              </a:ext>
            </a:extLst>
          </p:cNvPr>
          <p:cNvSpPr txBox="1"/>
          <p:nvPr/>
        </p:nvSpPr>
        <p:spPr>
          <a:xfrm>
            <a:off x="57707" y="1656366"/>
            <a:ext cx="3819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F559502-81CD-4F49-A998-566ED7A65478}"/>
              </a:ext>
            </a:extLst>
          </p:cNvPr>
          <p:cNvSpPr txBox="1"/>
          <p:nvPr/>
        </p:nvSpPr>
        <p:spPr>
          <a:xfrm>
            <a:off x="3943403" y="1656366"/>
            <a:ext cx="3819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5B4B60F-6919-1140-9B6D-E979C2CC5607}"/>
              </a:ext>
            </a:extLst>
          </p:cNvPr>
          <p:cNvSpPr txBox="1"/>
          <p:nvPr/>
        </p:nvSpPr>
        <p:spPr>
          <a:xfrm>
            <a:off x="7589871" y="1656366"/>
            <a:ext cx="3819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5E14C96-CB0E-AC43-889D-74E5C25D8441}"/>
              </a:ext>
            </a:extLst>
          </p:cNvPr>
          <p:cNvSpPr txBox="1"/>
          <p:nvPr/>
        </p:nvSpPr>
        <p:spPr>
          <a:xfrm rot="16200000">
            <a:off x="149489" y="5211712"/>
            <a:ext cx="1119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BMC lysate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3BEBA4D-BE48-AE4F-A755-05FECE4F5B51}"/>
              </a:ext>
            </a:extLst>
          </p:cNvPr>
          <p:cNvSpPr txBox="1"/>
          <p:nvPr/>
        </p:nvSpPr>
        <p:spPr>
          <a:xfrm rot="16200000">
            <a:off x="4029107" y="5235399"/>
            <a:ext cx="1119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BMC lysate</a:t>
            </a:r>
          </a:p>
        </p:txBody>
      </p:sp>
    </p:spTree>
    <p:extLst>
      <p:ext uri="{BB962C8B-B14F-4D97-AF65-F5344CB8AC3E}">
        <p14:creationId xmlns:p14="http://schemas.microsoft.com/office/powerpoint/2010/main" val="7335237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05F5876-C9B6-6A44-B3EE-7F1120FAFC0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419" t="4742" r="10227" b="9452"/>
          <a:stretch/>
        </p:blipFill>
        <p:spPr>
          <a:xfrm>
            <a:off x="877325" y="2026511"/>
            <a:ext cx="4066375" cy="334868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894620C-9AC3-404C-B329-FE5D8FA24DF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837" t="4444" r="4672" b="9516"/>
          <a:stretch/>
        </p:blipFill>
        <p:spPr>
          <a:xfrm>
            <a:off x="5914761" y="2026511"/>
            <a:ext cx="4188942" cy="334868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33" name="Group 32">
            <a:extLst>
              <a:ext uri="{FF2B5EF4-FFF2-40B4-BE49-F238E27FC236}">
                <a16:creationId xmlns:a16="http://schemas.microsoft.com/office/drawing/2014/main" id="{B96B5045-87C2-0C42-8A63-518DBAF29ABD}"/>
              </a:ext>
            </a:extLst>
          </p:cNvPr>
          <p:cNvGrpSpPr/>
          <p:nvPr/>
        </p:nvGrpSpPr>
        <p:grpSpPr>
          <a:xfrm>
            <a:off x="2382185" y="967350"/>
            <a:ext cx="1931356" cy="276999"/>
            <a:chOff x="2382185" y="967350"/>
            <a:chExt cx="1931356" cy="27699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0E4EFBB-DAEC-5F44-839B-8069E104A81E}"/>
                </a:ext>
              </a:extLst>
            </p:cNvPr>
            <p:cNvSpPr txBox="1"/>
            <p:nvPr/>
          </p:nvSpPr>
          <p:spPr>
            <a:xfrm>
              <a:off x="2382185" y="967350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18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00A171E-E66A-1648-BC25-C1453AC7CFE1}"/>
                </a:ext>
              </a:extLst>
            </p:cNvPr>
            <p:cNvSpPr txBox="1"/>
            <p:nvPr/>
          </p:nvSpPr>
          <p:spPr>
            <a:xfrm>
              <a:off x="3381428" y="967350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70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11075176-62E1-1B43-A090-F8E2C473587A}"/>
              </a:ext>
            </a:extLst>
          </p:cNvPr>
          <p:cNvSpPr txBox="1"/>
          <p:nvPr/>
        </p:nvSpPr>
        <p:spPr>
          <a:xfrm rot="16200000">
            <a:off x="2070627" y="1445611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AD35B0A-803E-B44F-ACF6-73896C93CE4F}"/>
              </a:ext>
            </a:extLst>
          </p:cNvPr>
          <p:cNvSpPr txBox="1"/>
          <p:nvPr/>
        </p:nvSpPr>
        <p:spPr>
          <a:xfrm rot="16200000">
            <a:off x="2542338" y="1667830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45AE32A-9294-5A43-A5FE-D399251CE49C}"/>
              </a:ext>
            </a:extLst>
          </p:cNvPr>
          <p:cNvSpPr txBox="1"/>
          <p:nvPr/>
        </p:nvSpPr>
        <p:spPr>
          <a:xfrm rot="16200000">
            <a:off x="2762942" y="1672596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9F4A3E1-FFE9-F84D-9223-19916D02B378}"/>
              </a:ext>
            </a:extLst>
          </p:cNvPr>
          <p:cNvSpPr txBox="1"/>
          <p:nvPr/>
        </p:nvSpPr>
        <p:spPr>
          <a:xfrm rot="16200000">
            <a:off x="2965733" y="1445611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3772076-38C6-6E44-BC90-D95411F79A20}"/>
              </a:ext>
            </a:extLst>
          </p:cNvPr>
          <p:cNvSpPr txBox="1"/>
          <p:nvPr/>
        </p:nvSpPr>
        <p:spPr>
          <a:xfrm rot="16200000">
            <a:off x="3437444" y="1667830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79041CF-DAA3-4A4A-8355-038A26513FDC}"/>
              </a:ext>
            </a:extLst>
          </p:cNvPr>
          <p:cNvSpPr txBox="1"/>
          <p:nvPr/>
        </p:nvSpPr>
        <p:spPr>
          <a:xfrm rot="16200000">
            <a:off x="3658048" y="1672596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FC76E61-A858-9E4C-8002-188058749FEF}"/>
              </a:ext>
            </a:extLst>
          </p:cNvPr>
          <p:cNvSpPr txBox="1"/>
          <p:nvPr/>
        </p:nvSpPr>
        <p:spPr>
          <a:xfrm rot="16200000">
            <a:off x="1458755" y="1440671"/>
            <a:ext cx="1024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ell lysate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EC1BC63F-46C0-474D-863D-3320DB508B08}"/>
              </a:ext>
            </a:extLst>
          </p:cNvPr>
          <p:cNvCxnSpPr>
            <a:cxnSpLocks/>
          </p:cNvCxnSpPr>
          <p:nvPr/>
        </p:nvCxnSpPr>
        <p:spPr>
          <a:xfrm flipH="1">
            <a:off x="4014577" y="4060650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6CD74D46-B049-F24B-9222-A7A453C5E844}"/>
              </a:ext>
            </a:extLst>
          </p:cNvPr>
          <p:cNvSpPr txBox="1"/>
          <p:nvPr/>
        </p:nvSpPr>
        <p:spPr>
          <a:xfrm>
            <a:off x="4193888" y="3942612"/>
            <a:ext cx="9321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POBEC3A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4053CD0-26A2-9141-8AED-ACFB032DF66B}"/>
              </a:ext>
            </a:extLst>
          </p:cNvPr>
          <p:cNvCxnSpPr>
            <a:cxnSpLocks/>
          </p:cNvCxnSpPr>
          <p:nvPr/>
        </p:nvCxnSpPr>
        <p:spPr>
          <a:xfrm>
            <a:off x="3476753" y="1193105"/>
            <a:ext cx="7497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8D21F1F-8411-5A40-B9C7-75875F740770}"/>
              </a:ext>
            </a:extLst>
          </p:cNvPr>
          <p:cNvCxnSpPr>
            <a:cxnSpLocks/>
          </p:cNvCxnSpPr>
          <p:nvPr/>
        </p:nvCxnSpPr>
        <p:spPr>
          <a:xfrm>
            <a:off x="2473371" y="1193105"/>
            <a:ext cx="7497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900AADD5-87DB-9149-9DF1-F2523C0EFFD5}"/>
              </a:ext>
            </a:extLst>
          </p:cNvPr>
          <p:cNvSpPr txBox="1"/>
          <p:nvPr/>
        </p:nvSpPr>
        <p:spPr>
          <a:xfrm rot="16200000">
            <a:off x="6901398" y="1445611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5D9786B-517D-A143-9DEA-914AC73D2FAD}"/>
              </a:ext>
            </a:extLst>
          </p:cNvPr>
          <p:cNvSpPr txBox="1"/>
          <p:nvPr/>
        </p:nvSpPr>
        <p:spPr>
          <a:xfrm rot="16200000">
            <a:off x="7373109" y="1667830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DDA7A44-3120-C64C-A807-8BBEF027C439}"/>
              </a:ext>
            </a:extLst>
          </p:cNvPr>
          <p:cNvSpPr txBox="1"/>
          <p:nvPr/>
        </p:nvSpPr>
        <p:spPr>
          <a:xfrm rot="16200000">
            <a:off x="7593713" y="1672596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D977B97-A4DD-3A49-B704-6255C76A5983}"/>
              </a:ext>
            </a:extLst>
          </p:cNvPr>
          <p:cNvSpPr txBox="1"/>
          <p:nvPr/>
        </p:nvSpPr>
        <p:spPr>
          <a:xfrm rot="16200000">
            <a:off x="7796504" y="1445611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D4ED359-D67F-1042-BDE7-0877546D3AC2}"/>
              </a:ext>
            </a:extLst>
          </p:cNvPr>
          <p:cNvSpPr txBox="1"/>
          <p:nvPr/>
        </p:nvSpPr>
        <p:spPr>
          <a:xfrm rot="16200000">
            <a:off x="8268215" y="1667830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4A3C961-2165-5C46-A433-E2B42C4DC3D9}"/>
              </a:ext>
            </a:extLst>
          </p:cNvPr>
          <p:cNvSpPr txBox="1"/>
          <p:nvPr/>
        </p:nvSpPr>
        <p:spPr>
          <a:xfrm rot="16200000">
            <a:off x="8488819" y="1672596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57C8725D-48C3-7240-BF0B-F49B51579A28}"/>
              </a:ext>
            </a:extLst>
          </p:cNvPr>
          <p:cNvCxnSpPr>
            <a:cxnSpLocks/>
          </p:cNvCxnSpPr>
          <p:nvPr/>
        </p:nvCxnSpPr>
        <p:spPr>
          <a:xfrm flipH="1">
            <a:off x="9124836" y="3574263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DE68C894-004C-2B4A-A03B-B8E20E813A8F}"/>
              </a:ext>
            </a:extLst>
          </p:cNvPr>
          <p:cNvSpPr txBox="1"/>
          <p:nvPr/>
        </p:nvSpPr>
        <p:spPr>
          <a:xfrm>
            <a:off x="9304147" y="3456225"/>
            <a:ext cx="9321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POBEC3A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664B5516-F03F-064A-BB93-31E729B1881D}"/>
              </a:ext>
            </a:extLst>
          </p:cNvPr>
          <p:cNvGrpSpPr/>
          <p:nvPr/>
        </p:nvGrpSpPr>
        <p:grpSpPr>
          <a:xfrm>
            <a:off x="7212956" y="967350"/>
            <a:ext cx="1931356" cy="276999"/>
            <a:chOff x="7212956" y="823899"/>
            <a:chExt cx="1931356" cy="276999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782F531-CA4E-D243-95E4-3D65DE58C24F}"/>
                </a:ext>
              </a:extLst>
            </p:cNvPr>
            <p:cNvSpPr txBox="1"/>
            <p:nvPr/>
          </p:nvSpPr>
          <p:spPr>
            <a:xfrm>
              <a:off x="7212956" y="823899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205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E28E89F-FA51-1440-A4EC-38450364F24F}"/>
                </a:ext>
              </a:extLst>
            </p:cNvPr>
            <p:cNvSpPr txBox="1"/>
            <p:nvPr/>
          </p:nvSpPr>
          <p:spPr>
            <a:xfrm>
              <a:off x="8212199" y="823899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008</a:t>
              </a: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7437BA12-180E-2648-96B8-902BE98E2287}"/>
                </a:ext>
              </a:extLst>
            </p:cNvPr>
            <p:cNvCxnSpPr>
              <a:cxnSpLocks/>
            </p:cNvCxnSpPr>
            <p:nvPr/>
          </p:nvCxnSpPr>
          <p:spPr>
            <a:xfrm>
              <a:off x="8307524" y="1073416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9390BB7E-D138-754E-9568-F1897AFB5858}"/>
                </a:ext>
              </a:extLst>
            </p:cNvPr>
            <p:cNvCxnSpPr>
              <a:cxnSpLocks/>
            </p:cNvCxnSpPr>
            <p:nvPr/>
          </p:nvCxnSpPr>
          <p:spPr>
            <a:xfrm>
              <a:off x="7304142" y="1073416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F35A6291-1A1F-7148-8671-DD15EA2074F4}"/>
              </a:ext>
            </a:extLst>
          </p:cNvPr>
          <p:cNvSpPr txBox="1"/>
          <p:nvPr/>
        </p:nvSpPr>
        <p:spPr>
          <a:xfrm>
            <a:off x="256016" y="5763299"/>
            <a:ext cx="1125363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4. Western blots for APOBEC3A shown in Fig. 9A without cropping for (A) Donors 118 and 170 and (B) Donors 205 and 008, probed respectively with polyclonal anti-APOBEC3A antibody from (A) NOVUS Biologicals or (B) Thermo Fisher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FAFB34A-86AC-4048-8F86-EABEFF382BF8}"/>
              </a:ext>
            </a:extLst>
          </p:cNvPr>
          <p:cNvSpPr txBox="1"/>
          <p:nvPr/>
        </p:nvSpPr>
        <p:spPr>
          <a:xfrm>
            <a:off x="675548" y="1656366"/>
            <a:ext cx="3819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3EB3524-F359-C14E-89F4-448979B0D674}"/>
              </a:ext>
            </a:extLst>
          </p:cNvPr>
          <p:cNvSpPr txBox="1"/>
          <p:nvPr/>
        </p:nvSpPr>
        <p:spPr>
          <a:xfrm>
            <a:off x="5698067" y="1656366"/>
            <a:ext cx="3819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323499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B5E6ED45-D6C3-A041-8D87-93E545CD776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686" t="5996"/>
          <a:stretch/>
        </p:blipFill>
        <p:spPr>
          <a:xfrm>
            <a:off x="6071286" y="2148194"/>
            <a:ext cx="4665013" cy="358895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F0861564-8988-7C42-9CC3-1016113A18FF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14878" t="18765" r="15908" b="3182"/>
          <a:stretch/>
        </p:blipFill>
        <p:spPr>
          <a:xfrm>
            <a:off x="882591" y="2153159"/>
            <a:ext cx="4663440" cy="359359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EBD5721B-335A-BD44-B41D-9FD17A7DCBE4}"/>
              </a:ext>
            </a:extLst>
          </p:cNvPr>
          <p:cNvSpPr txBox="1"/>
          <p:nvPr/>
        </p:nvSpPr>
        <p:spPr>
          <a:xfrm>
            <a:off x="576650" y="6083932"/>
            <a:ext cx="112536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5. Western blots for GAPDH shown in Fig. 9A without cropping for (A) Donors 118 and 170, (B) Donors 205 and 008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FCE6EA7-8D64-6F4A-BF01-B5350BD98073}"/>
              </a:ext>
            </a:extLst>
          </p:cNvPr>
          <p:cNvSpPr txBox="1"/>
          <p:nvPr/>
        </p:nvSpPr>
        <p:spPr>
          <a:xfrm>
            <a:off x="711136" y="1623927"/>
            <a:ext cx="381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B6511E5-9706-B246-9AD7-AE71F12D47E6}"/>
              </a:ext>
            </a:extLst>
          </p:cNvPr>
          <p:cNvSpPr txBox="1"/>
          <p:nvPr/>
        </p:nvSpPr>
        <p:spPr>
          <a:xfrm>
            <a:off x="5870872" y="1623927"/>
            <a:ext cx="381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C124221-4C46-9E42-B8D5-179A1E1328DD}"/>
              </a:ext>
            </a:extLst>
          </p:cNvPr>
          <p:cNvGrpSpPr/>
          <p:nvPr/>
        </p:nvGrpSpPr>
        <p:grpSpPr>
          <a:xfrm>
            <a:off x="2654035" y="1009877"/>
            <a:ext cx="1832500" cy="276999"/>
            <a:chOff x="2654035" y="796120"/>
            <a:chExt cx="1832500" cy="276999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77559DE-F015-2146-A26A-F42A2C399C17}"/>
                </a:ext>
              </a:extLst>
            </p:cNvPr>
            <p:cNvSpPr txBox="1"/>
            <p:nvPr/>
          </p:nvSpPr>
          <p:spPr>
            <a:xfrm>
              <a:off x="2654035" y="796120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18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4C4A61B-782D-694D-AEC8-2274EBD7B3C4}"/>
                </a:ext>
              </a:extLst>
            </p:cNvPr>
            <p:cNvSpPr txBox="1"/>
            <p:nvPr/>
          </p:nvSpPr>
          <p:spPr>
            <a:xfrm>
              <a:off x="3554422" y="796120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70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4DF2D1AC-DB5E-FB49-A66C-60FB96E2E12C}"/>
              </a:ext>
            </a:extLst>
          </p:cNvPr>
          <p:cNvSpPr txBox="1"/>
          <p:nvPr/>
        </p:nvSpPr>
        <p:spPr>
          <a:xfrm rot="16200000">
            <a:off x="2367191" y="1546230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FC65E9C-8CCC-F64F-B2B3-FFA4ACEF947C}"/>
              </a:ext>
            </a:extLst>
          </p:cNvPr>
          <p:cNvSpPr txBox="1"/>
          <p:nvPr/>
        </p:nvSpPr>
        <p:spPr>
          <a:xfrm rot="16200000">
            <a:off x="2838902" y="1768449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11439FC-E10A-CB4D-8A17-4C1644E558EE}"/>
              </a:ext>
            </a:extLst>
          </p:cNvPr>
          <p:cNvSpPr txBox="1"/>
          <p:nvPr/>
        </p:nvSpPr>
        <p:spPr>
          <a:xfrm rot="16200000">
            <a:off x="3133648" y="1773215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5F8D2B3-B02F-474A-B964-4F4185CB4F15}"/>
              </a:ext>
            </a:extLst>
          </p:cNvPr>
          <p:cNvSpPr txBox="1"/>
          <p:nvPr/>
        </p:nvSpPr>
        <p:spPr>
          <a:xfrm rot="16200000">
            <a:off x="3212869" y="1546230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0D27960-1D32-644D-BA67-F6F4AF292F65}"/>
              </a:ext>
            </a:extLst>
          </p:cNvPr>
          <p:cNvSpPr txBox="1"/>
          <p:nvPr/>
        </p:nvSpPr>
        <p:spPr>
          <a:xfrm rot="16200000">
            <a:off x="3734008" y="1768449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0F15EBF-87AE-FE45-B8EA-2AABFC79EDAE}"/>
              </a:ext>
            </a:extLst>
          </p:cNvPr>
          <p:cNvSpPr txBox="1"/>
          <p:nvPr/>
        </p:nvSpPr>
        <p:spPr>
          <a:xfrm rot="16200000">
            <a:off x="4016397" y="1773215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B097D66C-37A6-CE4D-9361-2F3FCFBEBB64}"/>
              </a:ext>
            </a:extLst>
          </p:cNvPr>
          <p:cNvCxnSpPr>
            <a:cxnSpLocks/>
          </p:cNvCxnSpPr>
          <p:nvPr/>
        </p:nvCxnSpPr>
        <p:spPr>
          <a:xfrm flipH="1">
            <a:off x="4447068" y="3751729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842919EA-E440-1149-AE6A-8226B8555CBA}"/>
              </a:ext>
            </a:extLst>
          </p:cNvPr>
          <p:cNvSpPr txBox="1"/>
          <p:nvPr/>
        </p:nvSpPr>
        <p:spPr>
          <a:xfrm>
            <a:off x="4626379" y="3633691"/>
            <a:ext cx="731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C3E73C00-F60F-6B44-8616-6EF9EF9BCB51}"/>
              </a:ext>
            </a:extLst>
          </p:cNvPr>
          <p:cNvCxnSpPr>
            <a:cxnSpLocks/>
          </p:cNvCxnSpPr>
          <p:nvPr/>
        </p:nvCxnSpPr>
        <p:spPr>
          <a:xfrm>
            <a:off x="3649747" y="1247506"/>
            <a:ext cx="7497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159CD261-3474-4A4C-BA9D-B93CF07B1E54}"/>
              </a:ext>
            </a:extLst>
          </p:cNvPr>
          <p:cNvCxnSpPr>
            <a:cxnSpLocks/>
          </p:cNvCxnSpPr>
          <p:nvPr/>
        </p:nvCxnSpPr>
        <p:spPr>
          <a:xfrm>
            <a:off x="2745221" y="1247506"/>
            <a:ext cx="7497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30D3A2DC-DEE7-054B-A608-A06B9073A2E9}"/>
              </a:ext>
            </a:extLst>
          </p:cNvPr>
          <p:cNvSpPr txBox="1"/>
          <p:nvPr/>
        </p:nvSpPr>
        <p:spPr>
          <a:xfrm rot="16200000">
            <a:off x="7080703" y="1546230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CCF8D45-8525-144A-9AB9-5F6D08942464}"/>
              </a:ext>
            </a:extLst>
          </p:cNvPr>
          <p:cNvSpPr txBox="1"/>
          <p:nvPr/>
        </p:nvSpPr>
        <p:spPr>
          <a:xfrm rot="16200000">
            <a:off x="7614199" y="1768449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3FB19FA-0544-294E-ACD3-6DC6836EFE9C}"/>
              </a:ext>
            </a:extLst>
          </p:cNvPr>
          <p:cNvSpPr txBox="1"/>
          <p:nvPr/>
        </p:nvSpPr>
        <p:spPr>
          <a:xfrm rot="16200000">
            <a:off x="7921302" y="1773215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F29F865-D14E-AB45-B75E-9A8EDB7CEEB6}"/>
              </a:ext>
            </a:extLst>
          </p:cNvPr>
          <p:cNvSpPr txBox="1"/>
          <p:nvPr/>
        </p:nvSpPr>
        <p:spPr>
          <a:xfrm rot="16200000">
            <a:off x="8049951" y="1546230"/>
            <a:ext cx="10430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o Adjuvant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F07F1C4-D857-0242-97EA-F19C5F23663B}"/>
              </a:ext>
            </a:extLst>
          </p:cNvPr>
          <p:cNvSpPr txBox="1"/>
          <p:nvPr/>
        </p:nvSpPr>
        <p:spPr>
          <a:xfrm rot="16200000">
            <a:off x="8595804" y="1768449"/>
            <a:ext cx="598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5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90D0260-60DA-DD4E-9337-D1C3AF5A0DF4}"/>
              </a:ext>
            </a:extLst>
          </p:cNvPr>
          <p:cNvSpPr txBox="1"/>
          <p:nvPr/>
        </p:nvSpPr>
        <p:spPr>
          <a:xfrm rot="16200000">
            <a:off x="8915264" y="1773215"/>
            <a:ext cx="589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FBAD787A-3A20-EE41-9D4A-1175FB94301F}"/>
              </a:ext>
            </a:extLst>
          </p:cNvPr>
          <p:cNvCxnSpPr>
            <a:cxnSpLocks/>
          </p:cNvCxnSpPr>
          <p:nvPr/>
        </p:nvCxnSpPr>
        <p:spPr>
          <a:xfrm flipH="1">
            <a:off x="9753709" y="3820339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1A0A5A48-AF6F-BC4A-8892-821DE29A0875}"/>
              </a:ext>
            </a:extLst>
          </p:cNvPr>
          <p:cNvSpPr txBox="1"/>
          <p:nvPr/>
        </p:nvSpPr>
        <p:spPr>
          <a:xfrm>
            <a:off x="9933020" y="3702301"/>
            <a:ext cx="7312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650DADD1-582C-2246-8CC7-45D6484DCE19}"/>
              </a:ext>
            </a:extLst>
          </p:cNvPr>
          <p:cNvGrpSpPr/>
          <p:nvPr/>
        </p:nvGrpSpPr>
        <p:grpSpPr>
          <a:xfrm>
            <a:off x="7404618" y="1009877"/>
            <a:ext cx="1832500" cy="276999"/>
            <a:chOff x="7404618" y="795407"/>
            <a:chExt cx="1832500" cy="276999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34AE53A-4970-6E4C-9782-1526FA893600}"/>
                </a:ext>
              </a:extLst>
            </p:cNvPr>
            <p:cNvSpPr txBox="1"/>
            <p:nvPr/>
          </p:nvSpPr>
          <p:spPr>
            <a:xfrm>
              <a:off x="7404618" y="795407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205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05FBF38-4E7B-EA4E-9EBC-20BEE0854577}"/>
                </a:ext>
              </a:extLst>
            </p:cNvPr>
            <p:cNvSpPr txBox="1"/>
            <p:nvPr/>
          </p:nvSpPr>
          <p:spPr>
            <a:xfrm>
              <a:off x="8305005" y="795407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008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FC7AF7A2-036C-6F43-BEC6-8982FEC92EBE}"/>
                </a:ext>
              </a:extLst>
            </p:cNvPr>
            <p:cNvCxnSpPr>
              <a:cxnSpLocks/>
            </p:cNvCxnSpPr>
            <p:nvPr/>
          </p:nvCxnSpPr>
          <p:spPr>
            <a:xfrm>
              <a:off x="8400330" y="1021168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E64260DF-C3CF-854E-8314-DE9748693090}"/>
                </a:ext>
              </a:extLst>
            </p:cNvPr>
            <p:cNvCxnSpPr>
              <a:cxnSpLocks/>
            </p:cNvCxnSpPr>
            <p:nvPr/>
          </p:nvCxnSpPr>
          <p:spPr>
            <a:xfrm>
              <a:off x="7495804" y="1021168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876329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F028A67-5C65-D240-B259-52F4BF9F5F9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225" t="4752" r="33039" b="50656"/>
          <a:stretch/>
        </p:blipFill>
        <p:spPr>
          <a:xfrm>
            <a:off x="976184" y="1717589"/>
            <a:ext cx="4164227" cy="264335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C238621-0A36-8243-8F78-E9CFEAC78D40}"/>
              </a:ext>
            </a:extLst>
          </p:cNvPr>
          <p:cNvSpPr txBox="1"/>
          <p:nvPr/>
        </p:nvSpPr>
        <p:spPr>
          <a:xfrm rot="16200000">
            <a:off x="2045159" y="1323394"/>
            <a:ext cx="599629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C4E2470-03D5-7249-8E44-5D594558510B}"/>
              </a:ext>
            </a:extLst>
          </p:cNvPr>
          <p:cNvSpPr txBox="1"/>
          <p:nvPr/>
        </p:nvSpPr>
        <p:spPr>
          <a:xfrm rot="16200000">
            <a:off x="2044008" y="1072704"/>
            <a:ext cx="1100960" cy="2462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61935AE-6CA6-1F41-B026-EBE5EA6521DF}"/>
              </a:ext>
            </a:extLst>
          </p:cNvPr>
          <p:cNvSpPr txBox="1"/>
          <p:nvPr/>
        </p:nvSpPr>
        <p:spPr>
          <a:xfrm rot="16200000">
            <a:off x="2418284" y="1157001"/>
            <a:ext cx="932366" cy="246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3A siRNA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677BC97C-B9BF-0644-871A-A9A8522FE203}"/>
              </a:ext>
            </a:extLst>
          </p:cNvPr>
          <p:cNvCxnSpPr>
            <a:cxnSpLocks/>
          </p:cNvCxnSpPr>
          <p:nvPr/>
        </p:nvCxnSpPr>
        <p:spPr>
          <a:xfrm flipH="1">
            <a:off x="4830128" y="2849679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32782849-1AB4-454A-8D39-585B997669B9}"/>
              </a:ext>
            </a:extLst>
          </p:cNvPr>
          <p:cNvSpPr txBox="1"/>
          <p:nvPr/>
        </p:nvSpPr>
        <p:spPr>
          <a:xfrm>
            <a:off x="5107331" y="2731641"/>
            <a:ext cx="9321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POBEC3A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8F58CB43-2464-A146-AE20-2751C3EA8D99}"/>
              </a:ext>
            </a:extLst>
          </p:cNvPr>
          <p:cNvGrpSpPr/>
          <p:nvPr/>
        </p:nvGrpSpPr>
        <p:grpSpPr>
          <a:xfrm>
            <a:off x="2110332" y="500197"/>
            <a:ext cx="2759263" cy="276999"/>
            <a:chOff x="2110332" y="2471498"/>
            <a:chExt cx="2759263" cy="276999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7A29652-2703-5749-A540-3252A6CB23EF}"/>
                </a:ext>
              </a:extLst>
            </p:cNvPr>
            <p:cNvSpPr txBox="1"/>
            <p:nvPr/>
          </p:nvSpPr>
          <p:spPr>
            <a:xfrm>
              <a:off x="2110332" y="2471498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18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DCBD2B5-A9B4-0947-95E9-E714565E10B8}"/>
                </a:ext>
              </a:extLst>
            </p:cNvPr>
            <p:cNvSpPr txBox="1"/>
            <p:nvPr/>
          </p:nvSpPr>
          <p:spPr>
            <a:xfrm>
              <a:off x="3937482" y="2471498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70</a:t>
              </a: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6AE01861-B76E-BB4D-A134-7B194652A263}"/>
                </a:ext>
              </a:extLst>
            </p:cNvPr>
            <p:cNvCxnSpPr>
              <a:cxnSpLocks/>
            </p:cNvCxnSpPr>
            <p:nvPr/>
          </p:nvCxnSpPr>
          <p:spPr>
            <a:xfrm>
              <a:off x="4032807" y="2697259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F607C99B-EB3F-584A-9B6E-7CEA74F40315}"/>
                </a:ext>
              </a:extLst>
            </p:cNvPr>
            <p:cNvCxnSpPr>
              <a:cxnSpLocks/>
            </p:cNvCxnSpPr>
            <p:nvPr/>
          </p:nvCxnSpPr>
          <p:spPr>
            <a:xfrm>
              <a:off x="2201518" y="2697259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6" name="Picture 15">
            <a:extLst>
              <a:ext uri="{FF2B5EF4-FFF2-40B4-BE49-F238E27FC236}">
                <a16:creationId xmlns:a16="http://schemas.microsoft.com/office/drawing/2014/main" id="{5AA60984-6EC2-C740-A9AB-B2C9E42C28F8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13097" t="3936" r="600" b="-2163"/>
          <a:stretch/>
        </p:blipFill>
        <p:spPr>
          <a:xfrm>
            <a:off x="6336521" y="1729942"/>
            <a:ext cx="4160520" cy="264261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DB8D850F-DEDF-A04A-9EBB-DAFA101E2DE7}"/>
              </a:ext>
            </a:extLst>
          </p:cNvPr>
          <p:cNvCxnSpPr>
            <a:cxnSpLocks/>
          </p:cNvCxnSpPr>
          <p:nvPr/>
        </p:nvCxnSpPr>
        <p:spPr>
          <a:xfrm flipH="1">
            <a:off x="9548610" y="3061562"/>
            <a:ext cx="22517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2CE9D6FF-61A5-A141-8781-9B7818219948}"/>
              </a:ext>
            </a:extLst>
          </p:cNvPr>
          <p:cNvSpPr txBox="1"/>
          <p:nvPr/>
        </p:nvSpPr>
        <p:spPr>
          <a:xfrm>
            <a:off x="9802063" y="2943524"/>
            <a:ext cx="9321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9CF22216-CA0F-F642-A1C1-65EFD0B12F1A}"/>
              </a:ext>
            </a:extLst>
          </p:cNvPr>
          <p:cNvGrpSpPr/>
          <p:nvPr/>
        </p:nvGrpSpPr>
        <p:grpSpPr>
          <a:xfrm>
            <a:off x="7323893" y="500195"/>
            <a:ext cx="2400915" cy="277001"/>
            <a:chOff x="7323893" y="2249626"/>
            <a:chExt cx="2400915" cy="277001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FFB1633-1D7C-3345-ADE4-8CF75519F347}"/>
                </a:ext>
              </a:extLst>
            </p:cNvPr>
            <p:cNvSpPr txBox="1"/>
            <p:nvPr/>
          </p:nvSpPr>
          <p:spPr>
            <a:xfrm>
              <a:off x="7323893" y="2249626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18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C62FBAE-3F4B-C244-95CC-A5FF64224144}"/>
                </a:ext>
              </a:extLst>
            </p:cNvPr>
            <p:cNvSpPr txBox="1"/>
            <p:nvPr/>
          </p:nvSpPr>
          <p:spPr>
            <a:xfrm>
              <a:off x="8792695" y="2249628"/>
              <a:ext cx="9321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onor 170</a:t>
              </a: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3AB5F2B2-32A8-5F4C-A77E-BB7204EC06CD}"/>
                </a:ext>
              </a:extLst>
            </p:cNvPr>
            <p:cNvCxnSpPr>
              <a:cxnSpLocks/>
            </p:cNvCxnSpPr>
            <p:nvPr/>
          </p:nvCxnSpPr>
          <p:spPr>
            <a:xfrm>
              <a:off x="8888020" y="2475389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86C0DF65-F125-9A40-A8C8-46CA25E12458}"/>
                </a:ext>
              </a:extLst>
            </p:cNvPr>
            <p:cNvCxnSpPr>
              <a:cxnSpLocks/>
            </p:cNvCxnSpPr>
            <p:nvPr/>
          </p:nvCxnSpPr>
          <p:spPr>
            <a:xfrm>
              <a:off x="7415079" y="2475387"/>
              <a:ext cx="7497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7F16DBDA-4959-3F40-837C-B2B01CB5803F}"/>
              </a:ext>
            </a:extLst>
          </p:cNvPr>
          <p:cNvSpPr txBox="1"/>
          <p:nvPr/>
        </p:nvSpPr>
        <p:spPr>
          <a:xfrm rot="16200000">
            <a:off x="3803939" y="1323394"/>
            <a:ext cx="599629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99D55A7-A40B-8C45-A71D-49AA2DE9F67E}"/>
              </a:ext>
            </a:extLst>
          </p:cNvPr>
          <p:cNvSpPr txBox="1"/>
          <p:nvPr/>
        </p:nvSpPr>
        <p:spPr>
          <a:xfrm rot="16200000">
            <a:off x="3876930" y="1072704"/>
            <a:ext cx="1100960" cy="2462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FB073FA-64A0-E54C-B8AA-18B461A55DBA}"/>
              </a:ext>
            </a:extLst>
          </p:cNvPr>
          <p:cNvSpPr txBox="1"/>
          <p:nvPr/>
        </p:nvSpPr>
        <p:spPr>
          <a:xfrm rot="16200000">
            <a:off x="4201778" y="1157001"/>
            <a:ext cx="932366" cy="246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3A siRN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2B1A777-58F2-C948-BEDF-1ABB89105C0D}"/>
              </a:ext>
            </a:extLst>
          </p:cNvPr>
          <p:cNvSpPr txBox="1"/>
          <p:nvPr/>
        </p:nvSpPr>
        <p:spPr>
          <a:xfrm rot="16200000">
            <a:off x="7321616" y="1323394"/>
            <a:ext cx="599629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0C6C077-0F4A-3F4E-8A56-22AEDD908448}"/>
              </a:ext>
            </a:extLst>
          </p:cNvPr>
          <p:cNvSpPr txBox="1"/>
          <p:nvPr/>
        </p:nvSpPr>
        <p:spPr>
          <a:xfrm rot="16200000">
            <a:off x="7285322" y="1072704"/>
            <a:ext cx="1100960" cy="2462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08FEB1F-F49A-4C4C-B7DE-C29F5077B468}"/>
              </a:ext>
            </a:extLst>
          </p:cNvPr>
          <p:cNvSpPr txBox="1"/>
          <p:nvPr/>
        </p:nvSpPr>
        <p:spPr>
          <a:xfrm rot="16200000">
            <a:off x="7610170" y="1157001"/>
            <a:ext cx="932366" cy="246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3A siRN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7B97462-BF4E-0643-9FA6-F35C217A9043}"/>
              </a:ext>
            </a:extLst>
          </p:cNvPr>
          <p:cNvSpPr txBox="1"/>
          <p:nvPr/>
        </p:nvSpPr>
        <p:spPr>
          <a:xfrm rot="16200000">
            <a:off x="8736330" y="1323394"/>
            <a:ext cx="599629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FQ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0CFBB6C-0F01-7C4D-9DB2-687A853CA904}"/>
              </a:ext>
            </a:extLst>
          </p:cNvPr>
          <p:cNvSpPr txBox="1"/>
          <p:nvPr/>
        </p:nvSpPr>
        <p:spPr>
          <a:xfrm rot="16200000">
            <a:off x="8698108" y="1072704"/>
            <a:ext cx="1100960" cy="2462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6BE2BE0-98B0-3E4B-A2FB-6A3FF7E0204E}"/>
              </a:ext>
            </a:extLst>
          </p:cNvPr>
          <p:cNvSpPr txBox="1"/>
          <p:nvPr/>
        </p:nvSpPr>
        <p:spPr>
          <a:xfrm rot="16200000">
            <a:off x="8973528" y="1157001"/>
            <a:ext cx="932366" cy="2462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3A siRN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7846F02-A2CC-1E49-AD7B-30B0BFE799B9}"/>
              </a:ext>
            </a:extLst>
          </p:cNvPr>
          <p:cNvSpPr txBox="1"/>
          <p:nvPr/>
        </p:nvSpPr>
        <p:spPr>
          <a:xfrm>
            <a:off x="822349" y="1290291"/>
            <a:ext cx="381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7C7E22D-E294-8D45-9090-0035BEE4240C}"/>
              </a:ext>
            </a:extLst>
          </p:cNvPr>
          <p:cNvSpPr txBox="1"/>
          <p:nvPr/>
        </p:nvSpPr>
        <p:spPr>
          <a:xfrm>
            <a:off x="6216865" y="1290291"/>
            <a:ext cx="381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3B04899-D436-B642-A0CF-6334047F39D2}"/>
              </a:ext>
            </a:extLst>
          </p:cNvPr>
          <p:cNvSpPr txBox="1"/>
          <p:nvPr/>
        </p:nvSpPr>
        <p:spPr>
          <a:xfrm>
            <a:off x="320438" y="5480807"/>
            <a:ext cx="1015359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. S6. Western blots for APOBEC3A and GAPDH shown in Fig. 10b without cropping for (A) APOBEC3A and (B) GAPDH for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onors 118 and 170.</a:t>
            </a:r>
          </a:p>
        </p:txBody>
      </p:sp>
    </p:spTree>
    <p:extLst>
      <p:ext uri="{BB962C8B-B14F-4D97-AF65-F5344CB8AC3E}">
        <p14:creationId xmlns:p14="http://schemas.microsoft.com/office/powerpoint/2010/main" val="3800917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5</TotalTime>
  <Words>441</Words>
  <Application>Microsoft Macintosh PowerPoint</Application>
  <PresentationFormat>Widescreen</PresentationFormat>
  <Paragraphs>14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usman Jobe</dc:creator>
  <cp:lastModifiedBy>Ousman Jobe</cp:lastModifiedBy>
  <cp:revision>13</cp:revision>
  <cp:lastPrinted>2022-03-09T16:22:00Z</cp:lastPrinted>
  <dcterms:created xsi:type="dcterms:W3CDTF">2022-03-09T16:03:58Z</dcterms:created>
  <dcterms:modified xsi:type="dcterms:W3CDTF">2022-05-04T14:58:44Z</dcterms:modified>
</cp:coreProperties>
</file>